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806" autoAdjust="0"/>
  </p:normalViewPr>
  <p:slideViewPr>
    <p:cSldViewPr>
      <p:cViewPr varScale="1">
        <p:scale>
          <a:sx n="46" d="100"/>
          <a:sy n="46" d="100"/>
        </p:scale>
        <p:origin x="2112" y="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3161209" y="127297"/>
            <a:ext cx="2644055" cy="1723014"/>
            <a:chOff x="3377233" y="6363235"/>
            <a:chExt cx="2644055" cy="1723014"/>
          </a:xfrm>
        </p:grpSpPr>
        <p:pic>
          <p:nvPicPr>
            <p:cNvPr id="5127" name="Picture 7" descr="C:\Users\ImageQuant\Desktop\Sonomi\Fstl1\2. NRFB\NRFB rec Fstl1 8-12-2014\NRFB2 tubulin\NRFB2 tubulin 20140923_1438_2.tif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77233" y="6363235"/>
              <a:ext cx="2644055" cy="172301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4" name="正方形/長方形 22"/>
            <p:cNvSpPr/>
            <p:nvPr/>
          </p:nvSpPr>
          <p:spPr>
            <a:xfrm>
              <a:off x="5000707" y="6916020"/>
              <a:ext cx="739031" cy="151392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テキスト ボックス 23"/>
            <p:cNvSpPr txBox="1"/>
            <p:nvPr/>
          </p:nvSpPr>
          <p:spPr>
            <a:xfrm>
              <a:off x="5015994" y="6626324"/>
              <a:ext cx="723980" cy="2289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bulin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332656" y="107504"/>
            <a:ext cx="2644055" cy="1756950"/>
            <a:chOff x="548680" y="6343442"/>
            <a:chExt cx="2644055" cy="1756950"/>
          </a:xfrm>
        </p:grpSpPr>
        <p:pic>
          <p:nvPicPr>
            <p:cNvPr id="5128" name="Picture 8" descr="C:\Users\ImageQuant\Desktop\Sonomi\Fstl1\2. NRFB\NRFB rec Fstl1 8-12-2014\NRFB2 Fstl1\NRFB2 Fstl1 20140918_1416_14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8680" y="6343442"/>
              <a:ext cx="2644055" cy="17569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8" name="正方形/長方形 22"/>
            <p:cNvSpPr/>
            <p:nvPr/>
          </p:nvSpPr>
          <p:spPr>
            <a:xfrm>
              <a:off x="2045990" y="7209870"/>
              <a:ext cx="739031" cy="151392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テキスト ボックス 23"/>
            <p:cNvSpPr txBox="1"/>
            <p:nvPr/>
          </p:nvSpPr>
          <p:spPr>
            <a:xfrm>
              <a:off x="2061277" y="6920174"/>
              <a:ext cx="5613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stl1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2" name="Group 3"/>
          <p:cNvGrpSpPr/>
          <p:nvPr/>
        </p:nvGrpSpPr>
        <p:grpSpPr>
          <a:xfrm>
            <a:off x="342732" y="3589307"/>
            <a:ext cx="2403686" cy="1602459"/>
            <a:chOff x="342732" y="1756945"/>
            <a:chExt cx="2403686" cy="1602459"/>
          </a:xfrm>
        </p:grpSpPr>
        <p:pic>
          <p:nvPicPr>
            <p:cNvPr id="36" name="Picture 2" descr="C:\Users\ImageQuant\Desktop\Sonomi\Fstl1\2. NRFB\NRFB rec Fstl1 8-12-2014\NRFB2 p-smad3\20140916_1406 p-smad3 _8.tif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2732" y="1756945"/>
              <a:ext cx="2403686" cy="160245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7" name="正方形/長方形 22"/>
            <p:cNvSpPr/>
            <p:nvPr/>
          </p:nvSpPr>
          <p:spPr>
            <a:xfrm>
              <a:off x="1700011" y="2341416"/>
              <a:ext cx="610769" cy="151392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テキスト ボックス 23"/>
            <p:cNvSpPr txBox="1"/>
            <p:nvPr/>
          </p:nvSpPr>
          <p:spPr>
            <a:xfrm>
              <a:off x="1553343" y="1871112"/>
              <a:ext cx="8675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Smad3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1" name="Group 6"/>
          <p:cNvGrpSpPr/>
          <p:nvPr/>
        </p:nvGrpSpPr>
        <p:grpSpPr>
          <a:xfrm>
            <a:off x="332656" y="1945966"/>
            <a:ext cx="2403686" cy="1602459"/>
            <a:chOff x="332656" y="161229"/>
            <a:chExt cx="2403686" cy="1602459"/>
          </a:xfrm>
        </p:grpSpPr>
        <p:pic>
          <p:nvPicPr>
            <p:cNvPr id="42" name="Picture 3" descr="C:\Users\ImageQuant\Desktop\Sonomi\Fstl1\2. NRFB\NRFB rec Fstl1 8-12-2014\NRFB2 p-smad2\p-smad2 NRFB2 20140812_2128_4.tif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2656" y="161229"/>
              <a:ext cx="2403686" cy="160245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5" name="正方形/長方形 22"/>
            <p:cNvSpPr/>
            <p:nvPr/>
          </p:nvSpPr>
          <p:spPr>
            <a:xfrm>
              <a:off x="1652386" y="674199"/>
              <a:ext cx="610769" cy="151392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テキスト ボックス 23"/>
            <p:cNvSpPr txBox="1"/>
            <p:nvPr/>
          </p:nvSpPr>
          <p:spPr>
            <a:xfrm>
              <a:off x="1543818" y="414586"/>
              <a:ext cx="8675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Smad2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0" name="テキスト ボックス 49"/>
          <p:cNvSpPr txBox="1"/>
          <p:nvPr/>
        </p:nvSpPr>
        <p:spPr>
          <a:xfrm>
            <a:off x="5788214" y="2375405"/>
            <a:ext cx="10251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EV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1" name="Group 9"/>
          <p:cNvGrpSpPr/>
          <p:nvPr/>
        </p:nvGrpSpPr>
        <p:grpSpPr>
          <a:xfrm>
            <a:off x="2801169" y="1934637"/>
            <a:ext cx="2835460" cy="1690635"/>
            <a:chOff x="2801169" y="149900"/>
            <a:chExt cx="2835460" cy="1690635"/>
          </a:xfrm>
        </p:grpSpPr>
        <p:pic>
          <p:nvPicPr>
            <p:cNvPr id="52" name="Picture 4" descr="C:\Users\ImageQuant\Desktop\Sonomi\Fstl1\2. NRFB\NRFB rec Fstl1 8-12-2014\NRFB2 t-smad2\t-smad2 20140815_14551_3.tif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01169" y="149900"/>
              <a:ext cx="2644055" cy="169063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3" name="正方形/長方形 22"/>
            <p:cNvSpPr/>
            <p:nvPr/>
          </p:nvSpPr>
          <p:spPr>
            <a:xfrm>
              <a:off x="4299860" y="722294"/>
              <a:ext cx="671846" cy="183184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" name="テキスト ボックス 23"/>
            <p:cNvSpPr txBox="1"/>
            <p:nvPr/>
          </p:nvSpPr>
          <p:spPr>
            <a:xfrm>
              <a:off x="4922972" y="659185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ad2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5" name="Group 10"/>
          <p:cNvGrpSpPr/>
          <p:nvPr/>
        </p:nvGrpSpPr>
        <p:grpSpPr>
          <a:xfrm>
            <a:off x="2820219" y="3457367"/>
            <a:ext cx="2790596" cy="1762705"/>
            <a:chOff x="2820219" y="1672630"/>
            <a:chExt cx="2790596" cy="1762705"/>
          </a:xfrm>
        </p:grpSpPr>
        <p:pic>
          <p:nvPicPr>
            <p:cNvPr id="56" name="Picture 5" descr="C:\Users\ImageQuant\Desktop\Sonomi\Fstl1\2. NRFB\NRFB rec Fstl1 8-12-2014\NRFB2 t-smad3\NRFB2 t-smad3 20140917_1412_16.tif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20219" y="1672630"/>
              <a:ext cx="2644055" cy="176270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7" name="正方形/長方形 22"/>
            <p:cNvSpPr/>
            <p:nvPr/>
          </p:nvSpPr>
          <p:spPr>
            <a:xfrm>
              <a:off x="4274046" y="2285774"/>
              <a:ext cx="671846" cy="151392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" name="テキスト ボックス 23"/>
            <p:cNvSpPr txBox="1"/>
            <p:nvPr/>
          </p:nvSpPr>
          <p:spPr>
            <a:xfrm>
              <a:off x="4897158" y="2206769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ad3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9" name="Group 11"/>
          <p:cNvGrpSpPr/>
          <p:nvPr/>
        </p:nvGrpSpPr>
        <p:grpSpPr>
          <a:xfrm>
            <a:off x="5589240" y="3446805"/>
            <a:ext cx="1046737" cy="1752558"/>
            <a:chOff x="639834" y="3435492"/>
            <a:chExt cx="1046737" cy="1752558"/>
          </a:xfrm>
        </p:grpSpPr>
        <p:pic>
          <p:nvPicPr>
            <p:cNvPr id="60" name="Picture 6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9834" y="3435492"/>
              <a:ext cx="1046737" cy="17525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1" name="正方形/長方形 22"/>
            <p:cNvSpPr/>
            <p:nvPr/>
          </p:nvSpPr>
          <p:spPr>
            <a:xfrm>
              <a:off x="892214" y="4078396"/>
              <a:ext cx="739031" cy="221652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" name="テキスト ボックス 23"/>
            <p:cNvSpPr txBox="1"/>
            <p:nvPr/>
          </p:nvSpPr>
          <p:spPr>
            <a:xfrm>
              <a:off x="907501" y="3823830"/>
              <a:ext cx="723980" cy="2289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bulin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4" name="Group 33"/>
          <p:cNvGrpSpPr>
            <a:grpSpLocks noChangeAspect="1"/>
          </p:cNvGrpSpPr>
          <p:nvPr/>
        </p:nvGrpSpPr>
        <p:grpSpPr>
          <a:xfrm>
            <a:off x="2996952" y="5283577"/>
            <a:ext cx="2879375" cy="1919583"/>
            <a:chOff x="3394529" y="4067944"/>
            <a:chExt cx="3199306" cy="2132872"/>
          </a:xfrm>
        </p:grpSpPr>
        <p:pic>
          <p:nvPicPr>
            <p:cNvPr id="35" name="Picture 7" descr="C:\Users\ImageQuant\Desktop\Sonomi\Fstl1\2. NRFB\NRFB 3-6-2015\si+rec Fstl1 (1) - SUP\Collagen I standard 20150307_1458_1_1_4.tif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94529" y="4067944"/>
              <a:ext cx="3199306" cy="213287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9" name="正方形/長方形 22"/>
            <p:cNvSpPr/>
            <p:nvPr/>
          </p:nvSpPr>
          <p:spPr>
            <a:xfrm>
              <a:off x="4120568" y="4736992"/>
              <a:ext cx="983650" cy="268199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テキスト ボックス 23"/>
            <p:cNvSpPr txBox="1"/>
            <p:nvPr/>
          </p:nvSpPr>
          <p:spPr>
            <a:xfrm>
              <a:off x="4088388" y="4396966"/>
              <a:ext cx="9172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llagen I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3" name="Group 62"/>
          <p:cNvGrpSpPr>
            <a:grpSpLocks noChangeAspect="1"/>
          </p:cNvGrpSpPr>
          <p:nvPr/>
        </p:nvGrpSpPr>
        <p:grpSpPr>
          <a:xfrm>
            <a:off x="332656" y="5299566"/>
            <a:ext cx="2879375" cy="1936730"/>
            <a:chOff x="445718" y="4067944"/>
            <a:chExt cx="3199306" cy="2151922"/>
          </a:xfrm>
        </p:grpSpPr>
        <p:pic>
          <p:nvPicPr>
            <p:cNvPr id="64" name="Picture 8" descr="C:\Users\ImageQuant\Desktop\Sonomi\Fstl1\2. NRFB\NRFB 3-6-2015\si+rec Fstl1 (1) - SUP\Fn\Fn 20150331_1433_1_4.tif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5718" y="4086994"/>
              <a:ext cx="3199306" cy="213287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5" name="正方形/長方形 22"/>
            <p:cNvSpPr/>
            <p:nvPr/>
          </p:nvSpPr>
          <p:spPr>
            <a:xfrm>
              <a:off x="1113491" y="4407970"/>
              <a:ext cx="983650" cy="268199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6" name="テキスト ボックス 23"/>
            <p:cNvSpPr txBox="1"/>
            <p:nvPr/>
          </p:nvSpPr>
          <p:spPr>
            <a:xfrm>
              <a:off x="1081311" y="4067944"/>
              <a:ext cx="9861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ibronectin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7" name="Group 66"/>
          <p:cNvGrpSpPr>
            <a:grpSpLocks noChangeAspect="1"/>
          </p:cNvGrpSpPr>
          <p:nvPr/>
        </p:nvGrpSpPr>
        <p:grpSpPr>
          <a:xfrm>
            <a:off x="420395" y="7169530"/>
            <a:ext cx="2617615" cy="1745077"/>
            <a:chOff x="232508" y="5940152"/>
            <a:chExt cx="2908460" cy="1938975"/>
          </a:xfrm>
        </p:grpSpPr>
        <p:pic>
          <p:nvPicPr>
            <p:cNvPr id="68" name="Picture 9" descr="C:\Users\ImageQuant\Desktop\Sonomi\Fstl1\2. NRFB\NRFB 3-6-2015\si+rec Fstl1 (1)\aSMA 20150307_1450_2.tif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2508" y="5940152"/>
              <a:ext cx="2908460" cy="19389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9" name="正方形/長方形 22"/>
            <p:cNvSpPr/>
            <p:nvPr/>
          </p:nvSpPr>
          <p:spPr>
            <a:xfrm>
              <a:off x="1026758" y="6856242"/>
              <a:ext cx="894227" cy="268199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0" name="テキスト ボックス 23"/>
            <p:cNvSpPr txBox="1"/>
            <p:nvPr/>
          </p:nvSpPr>
          <p:spPr>
            <a:xfrm>
              <a:off x="996659" y="6516216"/>
              <a:ext cx="6378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SMA</a:t>
              </a:r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1" name="Group 70"/>
          <p:cNvGrpSpPr>
            <a:grpSpLocks noChangeAspect="1"/>
          </p:cNvGrpSpPr>
          <p:nvPr/>
        </p:nvGrpSpPr>
        <p:grpSpPr>
          <a:xfrm>
            <a:off x="3403673" y="7241538"/>
            <a:ext cx="2617615" cy="1745077"/>
            <a:chOff x="3429000" y="6012160"/>
            <a:chExt cx="2908460" cy="1938975"/>
          </a:xfrm>
        </p:grpSpPr>
        <p:pic>
          <p:nvPicPr>
            <p:cNvPr id="72" name="Picture 10" descr="C:\Users\ImageQuant\Desktop\Sonomi\Fstl1\2. NRFB\NRFB 3-6-2015\si+rec Fstl1 (1)\TUBULIN\tubulin 20150331_1426_1_2.tif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29000" y="6012160"/>
              <a:ext cx="2908460" cy="19389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3" name="正方形/長方形 22"/>
            <p:cNvSpPr/>
            <p:nvPr/>
          </p:nvSpPr>
          <p:spPr>
            <a:xfrm>
              <a:off x="4200482" y="6856242"/>
              <a:ext cx="894227" cy="268199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4" name="テキスト ボックス 23"/>
            <p:cNvSpPr txBox="1"/>
            <p:nvPr/>
          </p:nvSpPr>
          <p:spPr>
            <a:xfrm>
              <a:off x="4170383" y="6516216"/>
              <a:ext cx="7239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bulin 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3" name="テキスト ボックス 1"/>
          <p:cNvSpPr txBox="1"/>
          <p:nvPr/>
        </p:nvSpPr>
        <p:spPr>
          <a:xfrm>
            <a:off x="5856907" y="698012"/>
            <a:ext cx="10791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</a:p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EV 4A. 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1"/>
          <p:cNvSpPr txBox="1"/>
          <p:nvPr/>
        </p:nvSpPr>
        <p:spPr>
          <a:xfrm>
            <a:off x="5788215" y="5942432"/>
            <a:ext cx="10251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EV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Straight Connector 74"/>
          <p:cNvCxnSpPr/>
          <p:nvPr/>
        </p:nvCxnSpPr>
        <p:spPr>
          <a:xfrm>
            <a:off x="179115" y="1907704"/>
            <a:ext cx="6543203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>
            <a:off x="179115" y="5292080"/>
            <a:ext cx="6543203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509878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68282384"/>
              </p:ext>
            </p:extLst>
          </p:nvPr>
        </p:nvGraphicFramePr>
        <p:xfrm>
          <a:off x="332656" y="467544"/>
          <a:ext cx="5184576" cy="475252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51891"/>
                <a:gridCol w="1273225"/>
                <a:gridCol w="814865"/>
                <a:gridCol w="814865"/>
                <a:gridCol w="814865"/>
                <a:gridCol w="814865"/>
              </a:tblGrid>
              <a:tr h="268621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igure EV. 4C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958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elative fold increase of p-Smad 2/Smad 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958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i Con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958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i Fstl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2282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023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98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958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i cont/ rec Fstl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.2222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.124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.794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958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i Fstl1/ rec Fstl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.037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.982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.543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958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958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elative fold increase of p-Smad 3/Smad 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958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i Con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958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i Fstl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.0548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0.837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.0025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958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i cont/ rec Fstl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8.6112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7.985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9.230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958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i Fstl1/ rec Fstl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9.38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8.067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8.3213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958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68621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igure EV. 4D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958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elative fold increase of αSMA/ Tubuli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958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i Con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0646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9353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1942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8057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958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i Cont/ rec Fstl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1835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7743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2588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7246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958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i Fstl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1445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920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255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8532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47958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i Fstl1/ rec Fstl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079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6902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1305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0.5829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93181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5</TotalTime>
  <Words>135</Words>
  <Application>Microsoft Office PowerPoint</Application>
  <PresentationFormat>On-screen Show (4:3)</PresentationFormat>
  <Paragraphs>7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ＭＳ Ｐゴシック</vt:lpstr>
      <vt:lpstr>Arial</vt:lpstr>
      <vt:lpstr>Calibri</vt:lpstr>
      <vt:lpstr>Office テーマ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onomi</dc:creator>
  <cp:lastModifiedBy>Whittaker, Linda D</cp:lastModifiedBy>
  <cp:revision>88</cp:revision>
  <dcterms:modified xsi:type="dcterms:W3CDTF">2016-04-22T18:44:09Z</dcterms:modified>
</cp:coreProperties>
</file>